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E25E649-3F16-4E02-A733-19D2CDBF48F0}" styleName="中間 3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2" d="100"/>
          <a:sy n="92" d="100"/>
        </p:scale>
        <p:origin x="-120" y="-2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2E41-112A-BE41-A258-FE04F31E4A9E}" type="datetimeFigureOut">
              <a:rPr kumimoji="1" lang="ja-JP" altLang="en-US" smtClean="0"/>
              <a:t>19/05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D2EAA-E276-FC4D-8065-3F132039D1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98025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2E41-112A-BE41-A258-FE04F31E4A9E}" type="datetimeFigureOut">
              <a:rPr kumimoji="1" lang="ja-JP" altLang="en-US" smtClean="0"/>
              <a:t>19/05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D2EAA-E276-FC4D-8065-3F132039D1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8149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2E41-112A-BE41-A258-FE04F31E4A9E}" type="datetimeFigureOut">
              <a:rPr kumimoji="1" lang="ja-JP" altLang="en-US" smtClean="0"/>
              <a:t>19/05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D2EAA-E276-FC4D-8065-3F132039D1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84695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2E41-112A-BE41-A258-FE04F31E4A9E}" type="datetimeFigureOut">
              <a:rPr kumimoji="1" lang="ja-JP" altLang="en-US" smtClean="0"/>
              <a:t>19/05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D2EAA-E276-FC4D-8065-3F132039D1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48225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2E41-112A-BE41-A258-FE04F31E4A9E}" type="datetimeFigureOut">
              <a:rPr kumimoji="1" lang="ja-JP" altLang="en-US" smtClean="0"/>
              <a:t>19/05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D2EAA-E276-FC4D-8065-3F132039D1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3920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2E41-112A-BE41-A258-FE04F31E4A9E}" type="datetimeFigureOut">
              <a:rPr kumimoji="1" lang="ja-JP" altLang="en-US" smtClean="0"/>
              <a:t>19/05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D2EAA-E276-FC4D-8065-3F132039D1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63614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2E41-112A-BE41-A258-FE04F31E4A9E}" type="datetimeFigureOut">
              <a:rPr kumimoji="1" lang="ja-JP" altLang="en-US" smtClean="0"/>
              <a:t>19/05/0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D2EAA-E276-FC4D-8065-3F132039D1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44163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2E41-112A-BE41-A258-FE04F31E4A9E}" type="datetimeFigureOut">
              <a:rPr kumimoji="1" lang="ja-JP" altLang="en-US" smtClean="0"/>
              <a:t>19/05/0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D2EAA-E276-FC4D-8065-3F132039D1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66979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2E41-112A-BE41-A258-FE04F31E4A9E}" type="datetimeFigureOut">
              <a:rPr kumimoji="1" lang="ja-JP" altLang="en-US" smtClean="0"/>
              <a:t>19/05/0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D2EAA-E276-FC4D-8065-3F132039D1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2414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2E41-112A-BE41-A258-FE04F31E4A9E}" type="datetimeFigureOut">
              <a:rPr kumimoji="1" lang="ja-JP" altLang="en-US" smtClean="0"/>
              <a:t>19/05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D2EAA-E276-FC4D-8065-3F132039D1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6265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2E41-112A-BE41-A258-FE04F31E4A9E}" type="datetimeFigureOut">
              <a:rPr kumimoji="1" lang="ja-JP" altLang="en-US" smtClean="0"/>
              <a:t>19/05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D2EAA-E276-FC4D-8065-3F132039D1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78104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F02E41-112A-BE41-A258-FE04F31E4A9E}" type="datetimeFigureOut">
              <a:rPr kumimoji="1" lang="ja-JP" altLang="en-US" smtClean="0"/>
              <a:t>19/05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2D2EAA-E276-FC4D-8065-3F132039D1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130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35020607"/>
              </p:ext>
            </p:extLst>
          </p:nvPr>
        </p:nvGraphicFramePr>
        <p:xfrm>
          <a:off x="454524" y="715210"/>
          <a:ext cx="7098634" cy="4269739"/>
        </p:xfrm>
        <a:graphic>
          <a:graphicData uri="http://schemas.openxmlformats.org/drawingml/2006/table">
            <a:tbl>
              <a:tblPr firstRow="1" bandRow="1">
                <a:tableStyleId>{6E25E649-3F16-4E02-A733-19D2CDBF48F0}</a:tableStyleId>
              </a:tblPr>
              <a:tblGrid>
                <a:gridCol w="668423"/>
                <a:gridCol w="2678601"/>
                <a:gridCol w="2562497"/>
                <a:gridCol w="1189113"/>
              </a:tblGrid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Exo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u="none" strike="noStrike" dirty="0" smtClean="0">
                        <a:solidFill>
                          <a:schemeClr val="tx1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  <a:p>
                      <a:pPr marL="0" marR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Forward primer</a:t>
                      </a:r>
                      <a:endParaRPr lang="en-US" sz="1200" b="0" u="none" strike="noStrike" dirty="0" smtClean="0">
                        <a:solidFill>
                          <a:schemeClr val="tx1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  <a:p>
                      <a:pPr algn="ctr" fontAlgn="ctr"/>
                      <a:r>
                        <a:rPr lang="en-US" sz="1200" b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Sequ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u="none" strike="noStrike" dirty="0" smtClean="0">
                        <a:solidFill>
                          <a:schemeClr val="tx1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  <a:p>
                      <a:pPr marL="0" marR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Reverse primer</a:t>
                      </a:r>
                      <a:endParaRPr lang="en-US" sz="1200" b="0" u="none" strike="noStrike" dirty="0" smtClean="0">
                        <a:solidFill>
                          <a:schemeClr val="tx1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  <a:p>
                      <a:pPr algn="ctr" fontAlgn="ctr"/>
                      <a:r>
                        <a:rPr lang="en-US" sz="1200" b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Sequ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Product </a:t>
                      </a:r>
                      <a:r>
                        <a:rPr lang="en-US" sz="1200" b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size</a:t>
                      </a:r>
                    </a:p>
                    <a:p>
                      <a:pPr algn="ctr" fontAlgn="ctr"/>
                      <a:r>
                        <a:rPr lang="en-US" sz="1200" b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(</a:t>
                      </a:r>
                      <a:r>
                        <a:rPr lang="en-US" sz="1200" b="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bp</a:t>
                      </a:r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)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/>
                          <a:cs typeface="Times New Roman"/>
                        </a:rPr>
                        <a:t>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/>
                          <a:cs typeface="Times New Roman"/>
                        </a:rPr>
                        <a:t>5'-CAGGGCAGCTATGTACATGTTG-3'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/>
                          <a:cs typeface="Times New Roman"/>
                        </a:rPr>
                        <a:t>5'-TGCTTGTCTAAGGCTGCTGT-3'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u="none" strike="noStrike">
                          <a:effectLst/>
                          <a:latin typeface="Times New Roman"/>
                          <a:cs typeface="Times New Roman"/>
                        </a:rPr>
                        <a:t>463</a:t>
                      </a:r>
                      <a:endParaRPr lang="is-I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u="none" strike="noStrike">
                          <a:effectLst/>
                          <a:latin typeface="Times New Roman"/>
                          <a:cs typeface="Times New Roman"/>
                        </a:rPr>
                        <a:t>2</a:t>
                      </a:r>
                      <a:endParaRPr lang="is-I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/>
                          <a:cs typeface="Times New Roman"/>
                        </a:rPr>
                        <a:t>5'-GTAGTCATCTGATAACATAGCT-3'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/>
                          <a:cs typeface="Times New Roman"/>
                        </a:rPr>
                        <a:t>5'-ATGATAGCAGCAGCTGTGTG-3'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u="none" strike="noStrike">
                          <a:effectLst/>
                          <a:latin typeface="Times New Roman"/>
                          <a:cs typeface="Times New Roman"/>
                        </a:rPr>
                        <a:t>715</a:t>
                      </a:r>
                      <a:endParaRPr lang="is-I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Times New Roman"/>
                          <a:cs typeface="Times New Roman"/>
                        </a:rPr>
                        <a:t>3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/>
                          <a:cs typeface="Times New Roman"/>
                        </a:rPr>
                        <a:t>5'-TAAGCTCCACAGGACTGGGA-3'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/>
                          <a:cs typeface="Times New Roman"/>
                        </a:rPr>
                        <a:t>5'-TCCTCAAACGCATACCTCAG-3'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u="none" strike="noStrike" dirty="0">
                          <a:effectLst/>
                          <a:latin typeface="Times New Roman"/>
                          <a:cs typeface="Times New Roman"/>
                        </a:rPr>
                        <a:t>374</a:t>
                      </a:r>
                      <a:endParaRPr lang="is-I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Times New Roman"/>
                          <a:cs typeface="Times New Roman"/>
                        </a:rPr>
                        <a:t>4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/>
                          <a:cs typeface="Times New Roman"/>
                        </a:rPr>
                        <a:t>5'-CTTGAACTTGGGCATGGGAC-3'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/>
                          <a:cs typeface="Times New Roman"/>
                        </a:rPr>
                        <a:t>5'-CTCATGGCCTTTGGGTACAA-3'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1200" u="none" strike="noStrike">
                          <a:effectLst/>
                          <a:latin typeface="Times New Roman"/>
                          <a:cs typeface="Times New Roman"/>
                        </a:rPr>
                        <a:t>360</a:t>
                      </a:r>
                      <a:endParaRPr lang="cs-CZ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Times New Roman"/>
                          <a:cs typeface="Times New Roman"/>
                        </a:rPr>
                        <a:t>5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/>
                          <a:cs typeface="Times New Roman"/>
                        </a:rPr>
                        <a:t>5'-GAGATTGCTTAGTAAGTGCA-3'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/>
                          <a:cs typeface="Times New Roman"/>
                        </a:rPr>
                        <a:t>5'-TAACCCACTACCCCGTGGAA-3'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u="none" strike="noStrike">
                          <a:effectLst/>
                          <a:latin typeface="Times New Roman"/>
                          <a:cs typeface="Times New Roman"/>
                        </a:rPr>
                        <a:t>504</a:t>
                      </a:r>
                      <a:endParaRPr lang="is-I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Times New Roman"/>
                          <a:cs typeface="Times New Roman"/>
                        </a:rPr>
                        <a:t>6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/>
                          <a:cs typeface="Times New Roman"/>
                        </a:rPr>
                        <a:t>5'-ATTAGTGGTATGTTCTCCTC-3'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/>
                          <a:cs typeface="Times New Roman"/>
                        </a:rPr>
                        <a:t>5'-TGAGATTACAGGCATGAGCC-3'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u="none" strike="noStrike">
                          <a:effectLst/>
                          <a:latin typeface="Times New Roman"/>
                          <a:cs typeface="Times New Roman"/>
                        </a:rPr>
                        <a:t>480</a:t>
                      </a:r>
                      <a:endParaRPr lang="is-I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Times New Roman"/>
                          <a:cs typeface="Times New Roman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/>
                          <a:cs typeface="Times New Roman"/>
                        </a:rPr>
                        <a:t>5'-TAGTTGCATGAGGTAGACAG-3'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/>
                          <a:cs typeface="Times New Roman"/>
                        </a:rPr>
                        <a:t>5'-TGCTTAAATCCCTTCAGTGA-3'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u="none" strike="noStrike">
                          <a:effectLst/>
                          <a:latin typeface="Times New Roman"/>
                          <a:cs typeface="Times New Roman"/>
                        </a:rPr>
                        <a:t>400</a:t>
                      </a:r>
                      <a:endParaRPr lang="is-I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Times New Roman"/>
                          <a:cs typeface="Times New Roman"/>
                        </a:rPr>
                        <a:t>8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/>
                          <a:cs typeface="Times New Roman"/>
                        </a:rPr>
                        <a:t>5'-CTTGGTATTCTAAGCCACAC-3'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/>
                          <a:cs typeface="Times New Roman"/>
                        </a:rPr>
                        <a:t>5'-CTTTGGACAACAGATCTTCT-3'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u="none" strike="noStrike" dirty="0">
                          <a:effectLst/>
                          <a:latin typeface="Times New Roman"/>
                          <a:cs typeface="Times New Roman"/>
                        </a:rPr>
                        <a:t>420</a:t>
                      </a:r>
                      <a:endParaRPr lang="is-I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Times New Roman"/>
                          <a:cs typeface="Times New Roman"/>
                        </a:rPr>
                        <a:t>9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/>
                          <a:cs typeface="Times New Roman"/>
                        </a:rPr>
                        <a:t>5'-TTGGTGGACTAAGGGTGACC-3'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/>
                          <a:cs typeface="Times New Roman"/>
                        </a:rPr>
                        <a:t>5'-CTGTCACCCCAATCCTCTTCCA-3'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/>
                          <a:cs typeface="Times New Roman"/>
                        </a:rPr>
                        <a:t>386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Times New Roman"/>
                          <a:cs typeface="Times New Roman"/>
                        </a:rPr>
                        <a:t>1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/>
                          <a:cs typeface="Times New Roman"/>
                        </a:rPr>
                        <a:t>5'-TCCCTCAGGTGTCCAGGCTT-3'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/>
                          <a:cs typeface="Times New Roman"/>
                        </a:rPr>
                        <a:t>5'-TTGGAGATTCACAGGAACAG-3'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ru-RU" sz="1200" u="none" strike="noStrike" dirty="0">
                          <a:effectLst/>
                          <a:latin typeface="Times New Roman"/>
                          <a:cs typeface="Times New Roman"/>
                        </a:rPr>
                        <a:t>570</a:t>
                      </a:r>
                      <a:endParaRPr lang="ru-RU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</a:tr>
            </a:tbl>
          </a:graphicData>
        </a:graphic>
      </p:graphicFrame>
      <p:sp>
        <p:nvSpPr>
          <p:cNvPr id="7" name="テキスト ボックス 6"/>
          <p:cNvSpPr txBox="1"/>
          <p:nvPr/>
        </p:nvSpPr>
        <p:spPr>
          <a:xfrm>
            <a:off x="454524" y="240632"/>
            <a:ext cx="44879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Times New Roman"/>
                <a:cs typeface="Times New Roman"/>
              </a:rPr>
              <a:t>Supplemental Table 2. Amplification primer sets for HMGCS2 exons. 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35817001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84</Words>
  <Application>Microsoft Macintosh PowerPoint</Application>
  <PresentationFormat>画面に合わせる (4:3)</PresentationFormat>
  <Paragraphs>5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神戸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李 知子</dc:creator>
  <cp:lastModifiedBy>李 知子</cp:lastModifiedBy>
  <cp:revision>4</cp:revision>
  <dcterms:created xsi:type="dcterms:W3CDTF">2019-03-04T01:10:18Z</dcterms:created>
  <dcterms:modified xsi:type="dcterms:W3CDTF">2019-05-09T05:33:46Z</dcterms:modified>
</cp:coreProperties>
</file>